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9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3B99DC-BD03-442E-8424-D36A1E7A28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8A1CF-E00F-4987-875C-3D257BF526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F6A00-6DF3-4508-A9DE-69A037700E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CDB56-2096-41CF-B35C-3EE763DE87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2B35C-68A5-4A42-A57E-0DDAABAB31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7EFA1-09A4-4723-8A35-10A74EB147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9119D6-7415-490A-952D-362A1C19C3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660C4-BFC8-41AF-ADB8-3B98B7B836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45989-D027-4E2A-AFD5-BAD3818FD5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F63494-C630-409A-AC31-038E27F5F4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E637A-D67E-4078-8DC3-5D9C2BC5BF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780CF7-A124-44C9-B0BA-B0A4A040AC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F5A9D2-46C0-47DF-91B5-B3C5B734FC5E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435640" y="3068640"/>
          <a:ext cx="1944720" cy="360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435640" y="3068640"/>
                    <a:ext cx="194472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 rot="16200000">
            <a:off x="5290200" y="205992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V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5641920" y="199620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6298200" y="206208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V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6650280" y="199764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505480" y="170172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577120" y="14130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ytop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513480" y="141300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Nucle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376400" y="2652840"/>
            <a:ext cx="75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513480" y="170172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200000">
            <a:off x="3277080" y="205992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V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6200000">
            <a:off x="3629160" y="199620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6200000">
            <a:off x="4285440" y="206208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V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4637160" y="199764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492360" y="170172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564360" y="14130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ytop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500720" y="141300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Nucle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500720" y="170172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505480" y="1413000"/>
            <a:ext cx="172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490920" y="1413000"/>
            <a:ext cx="172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068360" y="1125360"/>
            <a:ext cx="53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LoV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082560" y="112536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P2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"/>
          <p:cNvGrpSpPr/>
          <p:nvPr/>
        </p:nvGrpSpPr>
        <p:grpSpPr>
          <a:xfrm>
            <a:off x="3419640" y="2565360"/>
            <a:ext cx="1944360" cy="433440"/>
            <a:chOff x="3419640" y="2565360"/>
            <a:chExt cx="1944360" cy="433440"/>
          </a:xfrm>
        </p:grpSpPr>
        <p:graphicFrame>
          <p:nvGraphicFramePr>
            <p:cNvPr id="65" name=""/>
            <p:cNvGraphicFramePr/>
            <p:nvPr/>
          </p:nvGraphicFramePr>
          <p:xfrm>
            <a:off x="3419640" y="2565360"/>
            <a:ext cx="1944360" cy="43344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66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419640" y="2565360"/>
                      <a:ext cx="1944360" cy="43344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67" name=""/>
            <p:cNvSpPr/>
            <p:nvPr/>
          </p:nvSpPr>
          <p:spPr>
            <a:xfrm>
              <a:off x="4390920" y="2565360"/>
              <a:ext cx="0" cy="43344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8" name=""/>
          <p:cNvGrpSpPr/>
          <p:nvPr/>
        </p:nvGrpSpPr>
        <p:grpSpPr>
          <a:xfrm>
            <a:off x="5435640" y="2565360"/>
            <a:ext cx="1944720" cy="433440"/>
            <a:chOff x="5435640" y="2565360"/>
            <a:chExt cx="1944720" cy="433440"/>
          </a:xfrm>
        </p:grpSpPr>
        <p:graphicFrame>
          <p:nvGraphicFramePr>
            <p:cNvPr id="69" name=""/>
            <p:cNvGraphicFramePr/>
            <p:nvPr/>
          </p:nvGraphicFramePr>
          <p:xfrm>
            <a:off x="5435640" y="2565360"/>
            <a:ext cx="1944720" cy="4334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70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435640" y="2565360"/>
                      <a:ext cx="1944720" cy="43344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71" name=""/>
            <p:cNvSpPr/>
            <p:nvPr/>
          </p:nvSpPr>
          <p:spPr>
            <a:xfrm>
              <a:off x="6373800" y="2565360"/>
              <a:ext cx="0" cy="433440"/>
            </a:xfrm>
            <a:prstGeom prst="line">
              <a:avLst/>
            </a:prstGeom>
            <a:ln w="936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" name=""/>
          <p:cNvSpPr/>
          <p:nvPr/>
        </p:nvSpPr>
        <p:spPr>
          <a:xfrm>
            <a:off x="7376040" y="3079800"/>
            <a:ext cx="86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Ecadhe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3" name=""/>
          <p:cNvGraphicFramePr/>
          <p:nvPr/>
        </p:nvGraphicFramePr>
        <p:xfrm>
          <a:off x="3419640" y="3068640"/>
          <a:ext cx="1944360" cy="3603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4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419640" y="3068640"/>
                    <a:ext cx="194436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75" name=""/>
          <p:cNvGraphicFramePr/>
          <p:nvPr/>
        </p:nvGraphicFramePr>
        <p:xfrm>
          <a:off x="5435640" y="3068640"/>
          <a:ext cx="1944720" cy="3603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6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5435640" y="3068640"/>
                    <a:ext cx="194472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77" name=""/>
          <p:cNvGraphicFramePr/>
          <p:nvPr/>
        </p:nvGraphicFramePr>
        <p:xfrm>
          <a:off x="5435640" y="3502080"/>
          <a:ext cx="1944720" cy="50328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8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5435640" y="3502080"/>
                    <a:ext cx="1944720" cy="5032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79" name=""/>
          <p:cNvGraphicFramePr/>
          <p:nvPr/>
        </p:nvGraphicFramePr>
        <p:xfrm>
          <a:off x="3419640" y="3502080"/>
          <a:ext cx="1944360" cy="50472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80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419640" y="3502080"/>
                    <a:ext cx="1944360" cy="5047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81" name=""/>
          <p:cNvSpPr/>
          <p:nvPr/>
        </p:nvSpPr>
        <p:spPr>
          <a:xfrm>
            <a:off x="7377120" y="357516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Lam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2" name=""/>
          <p:cNvGraphicFramePr/>
          <p:nvPr/>
        </p:nvGraphicFramePr>
        <p:xfrm>
          <a:off x="1403280" y="3068640"/>
          <a:ext cx="1944720" cy="36036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83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1403280" y="3068640"/>
                    <a:ext cx="194472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84" name=""/>
          <p:cNvGraphicFramePr/>
          <p:nvPr/>
        </p:nvGraphicFramePr>
        <p:xfrm>
          <a:off x="1403280" y="2565360"/>
          <a:ext cx="1944720" cy="43200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85" name="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1403280" y="2565360"/>
                    <a:ext cx="1944720" cy="4320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86" name=""/>
          <p:cNvGraphicFramePr/>
          <p:nvPr/>
        </p:nvGraphicFramePr>
        <p:xfrm>
          <a:off x="1403280" y="3502080"/>
          <a:ext cx="1944720" cy="50328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87" name="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1403280" y="3502080"/>
                    <a:ext cx="1944720" cy="50328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88" name=""/>
          <p:cNvSpPr/>
          <p:nvPr/>
        </p:nvSpPr>
        <p:spPr>
          <a:xfrm rot="16200000">
            <a:off x="1259640" y="205992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V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rot="16200000">
            <a:off x="1611360" y="199620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16200000">
            <a:off x="2267640" y="206208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V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6200000">
            <a:off x="2619360" y="1997640"/>
            <a:ext cx="86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474920" y="170172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546560" y="14130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ytop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482920" y="141300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Nuclea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482920" y="1701720"/>
            <a:ext cx="720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473120" y="1413000"/>
            <a:ext cx="1728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051640" y="112536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T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292760" y="4508640"/>
            <a:ext cx="7163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. HT29, LoVo and GP2D cells expressing either the sh-Vec or the sh-N-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were fractionated into cytoplasmic and nuclear extracts. Western blotting using anti-Ecadherin an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anti-lamin antibodies reveals the quality of the preparations. </a:t>
            </a:r>
            <a:r>
              <a:rPr b="0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-catenin is shown above. The dotted li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indicate the removal of intervening lan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2200" y="43560"/>
            <a:ext cx="164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Vijaya Chandra et al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4T12:41:56Z</dcterms:created>
  <dc:creator>jschneik</dc:creator>
  <dc:description/>
  <dc:language>en-US</dc:language>
  <cp:lastModifiedBy>jschneik</cp:lastModifiedBy>
  <dcterms:modified xsi:type="dcterms:W3CDTF">2012-03-12T10:26:50Z</dcterms:modified>
  <cp:revision>47</cp:revision>
  <dc:subject/>
  <dc:title>Folie 1</dc:title>
</cp:coreProperties>
</file>